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s/slide5.xml" ContentType="application/vnd.openxmlformats-officedocument.presentationml.slide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s/slide4.xml" ContentType="application/vnd.openxmlformats-officedocument.presentationml.slide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slides/slide6.xml" ContentType="application/vnd.openxmlformats-officedocument.presentationml.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tableStyles.xml" ContentType="application/vnd.openxmlformats-officedocument.presentationml.tableStyles+xml"/>
  <Override PartName="/ppt/slideLayouts/slideLayout4.xml" ContentType="application/vnd.openxmlformats-officedocument.presentationml.slideLayout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8"/>
  </p:notesMasterIdLst>
  <p:sldIdLst>
    <p:sldId id="278" r:id="rId2"/>
    <p:sldId id="279" r:id="rId3"/>
    <p:sldId id="280" r:id="rId4"/>
    <p:sldId id="281" r:id="rId5"/>
    <p:sldId id="282" r:id="rId6"/>
    <p:sldId id="276" r:id="rId7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lrMru>
    <a:srgbClr val="0000FF"/>
    <a:srgbClr val="1903BD"/>
  </p:clrMru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6985" autoAdjust="0"/>
    <p:restoredTop sz="94660"/>
  </p:normalViewPr>
  <p:slideViewPr>
    <p:cSldViewPr>
      <p:cViewPr varScale="1">
        <p:scale>
          <a:sx n="87" d="100"/>
          <a:sy n="87" d="100"/>
        </p:scale>
        <p:origin x="-2544" y="-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r">
              <a:defRPr sz="1200"/>
            </a:lvl1pPr>
          </a:lstStyle>
          <a:p>
            <a:fld id="{CD13F842-1841-445C-9E98-A1A152CAE142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8" tIns="45719" rIns="91438" bIns="4571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vert="horz" lIns="91438" tIns="45719" rIns="91438" bIns="4571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829968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r">
              <a:defRPr sz="1200"/>
            </a:lvl1pPr>
          </a:lstStyle>
          <a:p>
            <a:fld id="{EBA425D1-E6FE-412A-BEFE-860562746D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984917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0339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58319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79202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26241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54018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85320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08489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42198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03264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32396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74239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99033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6.png"/><Relationship Id="rId3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6200" y="1447800"/>
            <a:ext cx="6616494" cy="7489686"/>
            <a:chOff x="76200" y="739914"/>
            <a:chExt cx="6616494" cy="7489686"/>
          </a:xfrm>
        </p:grpSpPr>
        <p:grpSp>
          <p:nvGrpSpPr>
            <p:cNvPr id="3" name="Group 2"/>
            <p:cNvGrpSpPr/>
            <p:nvPr/>
          </p:nvGrpSpPr>
          <p:grpSpPr>
            <a:xfrm>
              <a:off x="405545" y="1066800"/>
              <a:ext cx="5995255" cy="6997620"/>
              <a:chOff x="176945" y="1466850"/>
              <a:chExt cx="6604855" cy="7524750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17587" y="1466850"/>
                <a:ext cx="6064213" cy="69976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945" y="1466850"/>
                <a:ext cx="1880455" cy="1657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945" y="7233380"/>
                <a:ext cx="2419521" cy="17582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8" name="Rectangle 7"/>
            <p:cNvSpPr/>
            <p:nvPr/>
          </p:nvSpPr>
          <p:spPr>
            <a:xfrm>
              <a:off x="76200" y="739914"/>
              <a:ext cx="6616494" cy="748968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76200" y="76200"/>
            <a:ext cx="62484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Additional Fil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6: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Pathways significantly enriched based on early nutritional history in th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liver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6200" y="8382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Intermediary metabolism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74458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76200" y="76200"/>
            <a:ext cx="62484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Additional Fil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6: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Pathways significantly enriched based on early nutritional history in th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liver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6200" y="8382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Oxidation reduction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304800" y="1524000"/>
            <a:ext cx="6172200" cy="7162800"/>
            <a:chOff x="381000" y="1676400"/>
            <a:chExt cx="6172200" cy="7162800"/>
          </a:xfrm>
        </p:grpSpPr>
        <p:grpSp>
          <p:nvGrpSpPr>
            <p:cNvPr id="2" name="Group 1"/>
            <p:cNvGrpSpPr/>
            <p:nvPr/>
          </p:nvGrpSpPr>
          <p:grpSpPr>
            <a:xfrm>
              <a:off x="457200" y="1752600"/>
              <a:ext cx="5791200" cy="6934200"/>
              <a:chOff x="304800" y="838200"/>
              <a:chExt cx="6400800" cy="7772400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33400" y="838200"/>
                <a:ext cx="5864782" cy="58712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14600" y="6977318"/>
                <a:ext cx="4191000" cy="16332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4800" y="6977318"/>
                <a:ext cx="1834852" cy="16092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0" name="Rectangle 9"/>
            <p:cNvSpPr/>
            <p:nvPr/>
          </p:nvSpPr>
          <p:spPr>
            <a:xfrm>
              <a:off x="381000" y="1676400"/>
              <a:ext cx="6172200" cy="71628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230264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6200" y="1752600"/>
            <a:ext cx="6616494" cy="4724400"/>
            <a:chOff x="76200" y="914400"/>
            <a:chExt cx="6616494" cy="4724400"/>
          </a:xfrm>
        </p:grpSpPr>
        <p:grpSp>
          <p:nvGrpSpPr>
            <p:cNvPr id="3" name="Group 3"/>
            <p:cNvGrpSpPr/>
            <p:nvPr/>
          </p:nvGrpSpPr>
          <p:grpSpPr>
            <a:xfrm>
              <a:off x="304800" y="914400"/>
              <a:ext cx="6248400" cy="4572000"/>
              <a:chOff x="152401" y="381000"/>
              <a:chExt cx="6629399" cy="4914566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24168" y="381000"/>
                <a:ext cx="5957632" cy="448293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05200" y="4038600"/>
                <a:ext cx="3200400" cy="12270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2401" y="4343400"/>
                <a:ext cx="1507988" cy="9521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0" name="Rectangle 9"/>
            <p:cNvSpPr/>
            <p:nvPr/>
          </p:nvSpPr>
          <p:spPr>
            <a:xfrm>
              <a:off x="76200" y="914400"/>
              <a:ext cx="6616494" cy="47244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76200" y="76200"/>
            <a:ext cx="62484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Additional Fil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6: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Pathways significantly enriched based on early nutritional history in th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liver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6200" y="8382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Zymogens</a:t>
            </a: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74458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6200" y="1600200"/>
            <a:ext cx="6616494" cy="5410200"/>
            <a:chOff x="76200" y="990600"/>
            <a:chExt cx="6616494" cy="5410200"/>
          </a:xfrm>
        </p:grpSpPr>
        <p:grpSp>
          <p:nvGrpSpPr>
            <p:cNvPr id="3" name="Group 2"/>
            <p:cNvGrpSpPr/>
            <p:nvPr/>
          </p:nvGrpSpPr>
          <p:grpSpPr>
            <a:xfrm>
              <a:off x="381000" y="1019865"/>
              <a:ext cx="6096000" cy="5152335"/>
              <a:chOff x="97505" y="715065"/>
              <a:chExt cx="6441181" cy="5380935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0599" y="715065"/>
                <a:ext cx="5548087" cy="51314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2400" y="1276350"/>
                <a:ext cx="1744807" cy="1771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7505" y="4962525"/>
                <a:ext cx="2798095" cy="1133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8" name="Rectangle 7"/>
            <p:cNvSpPr/>
            <p:nvPr/>
          </p:nvSpPr>
          <p:spPr>
            <a:xfrm>
              <a:off x="76200" y="990600"/>
              <a:ext cx="6616494" cy="5410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76200" y="76200"/>
            <a:ext cx="62484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Additional Fil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6: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Pathways significantly enriched based on early nutritional history in th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liver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6200" y="8382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Peptidyl-prolyl isomerases</a:t>
            </a:r>
            <a:endParaRPr lang="en-US" sz="1600" b="1" dirty="0" smtClean="0">
              <a:latin typeface="Arial" pitchFamily="34" charset="0"/>
              <a:ea typeface="ＭＳ Ｐゴシック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744586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04800" y="1752600"/>
            <a:ext cx="6248400" cy="6096000"/>
            <a:chOff x="304800" y="1066800"/>
            <a:chExt cx="6248400" cy="6096000"/>
          </a:xfrm>
        </p:grpSpPr>
        <p:grpSp>
          <p:nvGrpSpPr>
            <p:cNvPr id="3" name="Group 2"/>
            <p:cNvGrpSpPr/>
            <p:nvPr/>
          </p:nvGrpSpPr>
          <p:grpSpPr>
            <a:xfrm>
              <a:off x="304800" y="1066800"/>
              <a:ext cx="6248400" cy="5867400"/>
              <a:chOff x="0" y="609600"/>
              <a:chExt cx="6764915" cy="6400800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609600"/>
                <a:ext cx="6764915" cy="57878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33800" y="5755742"/>
                <a:ext cx="2095500" cy="12546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57800" y="4114800"/>
                <a:ext cx="1351485" cy="13766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8" name="Rectangle 7"/>
            <p:cNvSpPr/>
            <p:nvPr/>
          </p:nvSpPr>
          <p:spPr>
            <a:xfrm>
              <a:off x="304800" y="1066800"/>
              <a:ext cx="6248400" cy="6096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76200" y="76200"/>
            <a:ext cx="62484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Additional Fil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6: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Pathways significantly enriched based on early nutritional history in th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liver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6200" y="8382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Cytoskeleton</a:t>
            </a:r>
            <a:endParaRPr lang="en-US" sz="1600" b="1" dirty="0" smtClean="0">
              <a:latin typeface="Arial" pitchFamily="34" charset="0"/>
              <a:ea typeface="ＭＳ Ｐゴシック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064391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52400" y="1371600"/>
            <a:ext cx="6553200" cy="7696200"/>
            <a:chOff x="304800" y="1725327"/>
            <a:chExt cx="6248400" cy="7266273"/>
          </a:xfrm>
        </p:grpSpPr>
        <p:grpSp>
          <p:nvGrpSpPr>
            <p:cNvPr id="2" name="Group 1"/>
            <p:cNvGrpSpPr/>
            <p:nvPr/>
          </p:nvGrpSpPr>
          <p:grpSpPr>
            <a:xfrm>
              <a:off x="477183" y="1725327"/>
              <a:ext cx="5923617" cy="7190073"/>
              <a:chOff x="172383" y="685800"/>
              <a:chExt cx="6457017" cy="8028273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2383" y="685800"/>
                <a:ext cx="6457017" cy="6638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87615" y="7143166"/>
                <a:ext cx="3912985" cy="15709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6" name="Rectangle 5"/>
            <p:cNvSpPr/>
            <p:nvPr/>
          </p:nvSpPr>
          <p:spPr>
            <a:xfrm>
              <a:off x="304800" y="1752600"/>
              <a:ext cx="6248400" cy="7239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76200" y="76200"/>
            <a:ext cx="62484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Additional Fil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6: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Pathways significantly enriched based on early nutritional history in the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liver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6200" y="8382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Cell cycle</a:t>
            </a: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230264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3</TotalTime>
  <Words>102</Words>
  <Application>Microsoft Macintosh PowerPoint</Application>
  <PresentationFormat>On-screen Show (4:3)</PresentationFormat>
  <Paragraphs>12</Paragraphs>
  <Slides>6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balasubram</dc:creator>
  <cp:lastModifiedBy>Mukundh</cp:lastModifiedBy>
  <cp:revision>123</cp:revision>
  <cp:lastPrinted>2014-08-04T13:17:26Z</cp:lastPrinted>
  <dcterms:created xsi:type="dcterms:W3CDTF">2016-04-14T00:49:57Z</dcterms:created>
  <dcterms:modified xsi:type="dcterms:W3CDTF">2016-04-14T01:06:18Z</dcterms:modified>
</cp:coreProperties>
</file>